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83" autoAdjust="0"/>
    <p:restoredTop sz="94660"/>
  </p:normalViewPr>
  <p:slideViewPr>
    <p:cSldViewPr snapToGrid="0">
      <p:cViewPr varScale="1">
        <p:scale>
          <a:sx n="79" d="100"/>
          <a:sy n="79" d="100"/>
        </p:scale>
        <p:origin x="82" y="2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040E34-D3CD-46D4-BDED-8306F88ACCB0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B2A68D-1527-483F-89DA-4587EE97B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421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B2A68D-1527-483F-89DA-4587EE97BF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598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F517E9-313E-03EF-88DB-1713775175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3B32E88-82B1-B343-B5D7-AB2FF75E53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EDAE93-15EF-C893-5AC9-D780133F7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D663E9-9C5F-F47D-C0C7-7A9E25D1A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246346-499E-B96F-5343-4F6060D03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777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73A578-CD9A-7B55-1CEB-846FA6A34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4F6DA24-E68F-292D-0465-B4B7911398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E24C85-D4ED-5625-0FAB-F56772D93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3138EA-A6FE-F22D-FF51-5838F288E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7D5AB8-D758-F0A7-C69C-A46784E46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359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8F59311-E7B5-AECD-FDFD-77351C893F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9AA818D-5658-210B-DFA5-E43B0B3288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D94C1C-3E22-F758-124B-4ECCD9AC2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257FB6-BCF3-EDD0-CB5C-1F8744348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A77246-C17E-2319-A075-D00D174C9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925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A7CC7F-E37F-18A4-6150-3DCC3904D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9C24D9-9AEE-2188-9116-B7F027961B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11515E-0B89-2BDA-2989-04EA6833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D66068-B75F-A825-3D8D-F84545501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F0342A-0397-6D43-C8C0-C28813419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128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7AF637-FAFD-FD07-367D-35938BB8F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588AF5-4D1D-A46F-BE32-02563C94FE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974CE2-2B80-3922-D04F-0D914BC2F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DDEE70-C30B-9DA2-D455-C2211DFA1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52EE03-0587-DE23-654E-1EB56DC4C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439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260CD1-0086-A337-21A6-A7FDBB4E7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B052B7-B78A-930C-B817-0103E99050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3D96F22-7F29-F494-A2E0-C6D849A092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80BD9D-A3CC-3C07-BECA-B9392981C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9E1956-48CA-DAC8-4ADE-D5B4C7BF0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BAC692-795E-9F7F-6B5B-A7D966510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3012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03BD4D-FEDF-D733-C85F-C36548023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94C58D-2A80-DCFC-C2C1-D037AB6A2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3526F6C-A5FF-0A5A-530D-378EEDB64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085CAD-851E-2ADD-42A1-C869A0131A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2373842-3BFF-3107-0B32-7AF12669BF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44C2F57-FB72-43DD-8461-F4F6DD450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26EAD23-B70B-369E-E798-B66EFDF19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63BEE31-F33E-ADBE-035E-322622930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655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814214-2E11-D0ED-FF6A-80474F3DA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D165DE0-EF4C-BE07-46F8-D21E2B08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BB64AFC-B49A-E6AC-D3EA-CA4CE896A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BB838BF-2AB5-07AE-6CB3-CD5AEB1D0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671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B05193B-6FFB-03AB-97CB-B255FFB57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6B5881F-4EF8-5A59-2828-E05A60539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50CB0A1-5836-D1F7-1393-58085FF59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827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677D48-9A6C-3A9B-88D2-0D5994163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FB62A8C-8529-4AC4-426D-8101A38527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782E4D-FB1F-7BD3-27E8-52D03ACD4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DB90EA-F52F-6938-D09D-C501F0C56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52E4007-4554-5623-ECCA-BBD66B82A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56B699-6140-4533-B3A9-2E27025E6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378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E13806-6E12-006C-3237-324E22508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CA63621-B015-34F3-BF30-EFFECC3BB6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B25A7EB-6B98-5671-CF42-484861C7EE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4B4E43-3F2D-0A2D-B152-41725AADE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04FCC6-E09A-5B45-4F38-B3E540E22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1C0AE77-3191-C04F-1846-16C426146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449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D64971A-B89A-06A9-9A82-0574B2567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FB64FE-E60E-CCA5-C9B8-9126E0E27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9450E3-5742-5342-622D-823F13D5ED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7BCE4-109B-4E6A-ADFB-390DA165784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AE2F3E-1057-A59C-E34E-8F8288F627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AF0586-E34E-3658-629D-BB4E17E362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DA8E5-5506-422E-BF07-A71C43A899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698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49E882-8F33-6C6C-62DC-AE8F6F523B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96F025E-7ED8-1BDC-2AE4-067267E36A68}"/>
              </a:ext>
            </a:extLst>
          </p:cNvPr>
          <p:cNvSpPr txBox="1"/>
          <p:nvPr/>
        </p:nvSpPr>
        <p:spPr>
          <a:xfrm>
            <a:off x="274349" y="103284"/>
            <a:ext cx="4741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atment scheme</a:t>
            </a:r>
            <a:endParaRPr lang="ja-JP" altLang="ja-JP" sz="1400" b="1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A1EE9E3-8501-DBA1-1311-6CE3114A64E2}"/>
              </a:ext>
            </a:extLst>
          </p:cNvPr>
          <p:cNvSpPr txBox="1"/>
          <p:nvPr/>
        </p:nvSpPr>
        <p:spPr>
          <a:xfrm>
            <a:off x="4141357" y="4980424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B78B54C-5A0A-6956-8325-C18C84F43243}"/>
              </a:ext>
            </a:extLst>
          </p:cNvPr>
          <p:cNvSpPr txBox="1"/>
          <p:nvPr/>
        </p:nvSpPr>
        <p:spPr>
          <a:xfrm>
            <a:off x="4874378" y="4980424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C4ACEBD-625D-8B5C-5763-13468CA24CF1}"/>
              </a:ext>
            </a:extLst>
          </p:cNvPr>
          <p:cNvSpPr txBox="1"/>
          <p:nvPr/>
        </p:nvSpPr>
        <p:spPr>
          <a:xfrm>
            <a:off x="5607400" y="4980424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矢印: 下 20">
            <a:extLst>
              <a:ext uri="{FF2B5EF4-FFF2-40B4-BE49-F238E27FC236}">
                <a16:creationId xmlns:a16="http://schemas.microsoft.com/office/drawing/2014/main" id="{687C2596-4A5B-DC0C-6E99-B6DDEA46EEF7}"/>
              </a:ext>
            </a:extLst>
          </p:cNvPr>
          <p:cNvSpPr/>
          <p:nvPr/>
        </p:nvSpPr>
        <p:spPr>
          <a:xfrm>
            <a:off x="4141357" y="4644168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矢印: 下 21">
            <a:extLst>
              <a:ext uri="{FF2B5EF4-FFF2-40B4-BE49-F238E27FC236}">
                <a16:creationId xmlns:a16="http://schemas.microsoft.com/office/drawing/2014/main" id="{835E12C5-CDAE-2CB6-CB09-92099C835EFD}"/>
              </a:ext>
            </a:extLst>
          </p:cNvPr>
          <p:cNvSpPr/>
          <p:nvPr/>
        </p:nvSpPr>
        <p:spPr>
          <a:xfrm>
            <a:off x="4913857" y="4644169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矢印: 下 22">
            <a:extLst>
              <a:ext uri="{FF2B5EF4-FFF2-40B4-BE49-F238E27FC236}">
                <a16:creationId xmlns:a16="http://schemas.microsoft.com/office/drawing/2014/main" id="{846E0615-62EF-3F15-B585-B4F00DCC570E}"/>
              </a:ext>
            </a:extLst>
          </p:cNvPr>
          <p:cNvSpPr/>
          <p:nvPr/>
        </p:nvSpPr>
        <p:spPr>
          <a:xfrm>
            <a:off x="5594404" y="4644169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矢印: 下 23">
            <a:extLst>
              <a:ext uri="{FF2B5EF4-FFF2-40B4-BE49-F238E27FC236}">
                <a16:creationId xmlns:a16="http://schemas.microsoft.com/office/drawing/2014/main" id="{EC704318-60CE-BD7C-C231-488E7B5FCBEC}"/>
              </a:ext>
            </a:extLst>
          </p:cNvPr>
          <p:cNvSpPr/>
          <p:nvPr/>
        </p:nvSpPr>
        <p:spPr>
          <a:xfrm>
            <a:off x="7076177" y="4650462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矢印: 下 24">
            <a:extLst>
              <a:ext uri="{FF2B5EF4-FFF2-40B4-BE49-F238E27FC236}">
                <a16:creationId xmlns:a16="http://schemas.microsoft.com/office/drawing/2014/main" id="{9C181084-665A-82A2-5A1F-F65417B59E4D}"/>
              </a:ext>
            </a:extLst>
          </p:cNvPr>
          <p:cNvSpPr/>
          <p:nvPr/>
        </p:nvSpPr>
        <p:spPr>
          <a:xfrm>
            <a:off x="7792437" y="4626116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EA587530-B09D-CEEA-678A-FECE68395F33}"/>
              </a:ext>
            </a:extLst>
          </p:cNvPr>
          <p:cNvSpPr/>
          <p:nvPr/>
        </p:nvSpPr>
        <p:spPr>
          <a:xfrm>
            <a:off x="6342776" y="4980425"/>
            <a:ext cx="718994" cy="683794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B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E2E7F98-0B37-70E0-1B53-F832361FE353}"/>
              </a:ext>
            </a:extLst>
          </p:cNvPr>
          <p:cNvSpPr txBox="1"/>
          <p:nvPr/>
        </p:nvSpPr>
        <p:spPr>
          <a:xfrm>
            <a:off x="7058705" y="4979971"/>
            <a:ext cx="733021" cy="33233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154BB5C-9CE4-62C1-7E30-784EDF8D3472}"/>
              </a:ext>
            </a:extLst>
          </p:cNvPr>
          <p:cNvSpPr txBox="1"/>
          <p:nvPr/>
        </p:nvSpPr>
        <p:spPr>
          <a:xfrm>
            <a:off x="7794095" y="4977780"/>
            <a:ext cx="733021" cy="33233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31F8987-B1DF-6D22-CF80-E8DB619DA9D6}"/>
              </a:ext>
            </a:extLst>
          </p:cNvPr>
          <p:cNvSpPr txBox="1"/>
          <p:nvPr/>
        </p:nvSpPr>
        <p:spPr>
          <a:xfrm>
            <a:off x="2775951" y="4980424"/>
            <a:ext cx="1131544" cy="332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RT+BT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3DE5326-4430-A245-9E6B-0680A7F59E98}"/>
              </a:ext>
            </a:extLst>
          </p:cNvPr>
          <p:cNvSpPr txBox="1"/>
          <p:nvPr/>
        </p:nvSpPr>
        <p:spPr>
          <a:xfrm>
            <a:off x="8524748" y="4982246"/>
            <a:ext cx="733021" cy="332330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58D2731-366C-B911-002E-811A32AE8C10}"/>
              </a:ext>
            </a:extLst>
          </p:cNvPr>
          <p:cNvSpPr txBox="1"/>
          <p:nvPr/>
        </p:nvSpPr>
        <p:spPr>
          <a:xfrm>
            <a:off x="1434420" y="4622381"/>
            <a:ext cx="660743" cy="332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BT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95B29FF-76BA-663C-78A9-04C8FDF4E020}"/>
              </a:ext>
            </a:extLst>
          </p:cNvPr>
          <p:cNvSpPr txBox="1"/>
          <p:nvPr/>
        </p:nvSpPr>
        <p:spPr>
          <a:xfrm>
            <a:off x="4151724" y="2673831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0D21978-53AE-ED4F-838D-7BF1ABE904D9}"/>
              </a:ext>
            </a:extLst>
          </p:cNvPr>
          <p:cNvSpPr txBox="1"/>
          <p:nvPr/>
        </p:nvSpPr>
        <p:spPr>
          <a:xfrm>
            <a:off x="4884746" y="2673831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313ACB1-9740-1A44-7856-E488926F72EA}"/>
              </a:ext>
            </a:extLst>
          </p:cNvPr>
          <p:cNvSpPr txBox="1"/>
          <p:nvPr/>
        </p:nvSpPr>
        <p:spPr>
          <a:xfrm>
            <a:off x="5617767" y="2673831"/>
            <a:ext cx="733021" cy="33233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矢印: 下 37">
            <a:extLst>
              <a:ext uri="{FF2B5EF4-FFF2-40B4-BE49-F238E27FC236}">
                <a16:creationId xmlns:a16="http://schemas.microsoft.com/office/drawing/2014/main" id="{F7BDFAFC-83BE-73AD-3A8D-F9DCF02AC378}"/>
              </a:ext>
            </a:extLst>
          </p:cNvPr>
          <p:cNvSpPr/>
          <p:nvPr/>
        </p:nvSpPr>
        <p:spPr>
          <a:xfrm>
            <a:off x="4151724" y="2337575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矢印: 下 38">
            <a:extLst>
              <a:ext uri="{FF2B5EF4-FFF2-40B4-BE49-F238E27FC236}">
                <a16:creationId xmlns:a16="http://schemas.microsoft.com/office/drawing/2014/main" id="{7AF5D842-AE1A-4190-3B01-6EED519F21BA}"/>
              </a:ext>
            </a:extLst>
          </p:cNvPr>
          <p:cNvSpPr/>
          <p:nvPr/>
        </p:nvSpPr>
        <p:spPr>
          <a:xfrm>
            <a:off x="4924225" y="2337575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矢印: 下 39">
            <a:extLst>
              <a:ext uri="{FF2B5EF4-FFF2-40B4-BE49-F238E27FC236}">
                <a16:creationId xmlns:a16="http://schemas.microsoft.com/office/drawing/2014/main" id="{90E27BA5-7212-A109-3913-F586FBDA0EA4}"/>
              </a:ext>
            </a:extLst>
          </p:cNvPr>
          <p:cNvSpPr/>
          <p:nvPr/>
        </p:nvSpPr>
        <p:spPr>
          <a:xfrm>
            <a:off x="5604771" y="2337575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矢印: 下 40">
            <a:extLst>
              <a:ext uri="{FF2B5EF4-FFF2-40B4-BE49-F238E27FC236}">
                <a16:creationId xmlns:a16="http://schemas.microsoft.com/office/drawing/2014/main" id="{7E580269-8194-9F66-5F03-02BF6E59EB96}"/>
              </a:ext>
            </a:extLst>
          </p:cNvPr>
          <p:cNvSpPr/>
          <p:nvPr/>
        </p:nvSpPr>
        <p:spPr>
          <a:xfrm>
            <a:off x="6787444" y="2348142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矢印: 下 41">
            <a:extLst>
              <a:ext uri="{FF2B5EF4-FFF2-40B4-BE49-F238E27FC236}">
                <a16:creationId xmlns:a16="http://schemas.microsoft.com/office/drawing/2014/main" id="{A4D7EB0F-4395-64BA-44FB-375DFFBCDB56}"/>
              </a:ext>
            </a:extLst>
          </p:cNvPr>
          <p:cNvSpPr/>
          <p:nvPr/>
        </p:nvSpPr>
        <p:spPr>
          <a:xfrm>
            <a:off x="8000663" y="2355660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7474F0DB-A976-DE53-79A7-6C22174DF9DA}"/>
              </a:ext>
            </a:extLst>
          </p:cNvPr>
          <p:cNvSpPr/>
          <p:nvPr/>
        </p:nvSpPr>
        <p:spPr>
          <a:xfrm>
            <a:off x="6357416" y="2673831"/>
            <a:ext cx="480883" cy="1016124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/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</a:p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00D2897-1F01-41D9-CCE8-0E71C01BAB38}"/>
              </a:ext>
            </a:extLst>
          </p:cNvPr>
          <p:cNvSpPr txBox="1"/>
          <p:nvPr/>
        </p:nvSpPr>
        <p:spPr>
          <a:xfrm>
            <a:off x="6832053" y="2673831"/>
            <a:ext cx="733021" cy="33233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44FDBE0-7889-231A-23AA-E9D2C47C4A56}"/>
              </a:ext>
            </a:extLst>
          </p:cNvPr>
          <p:cNvSpPr txBox="1"/>
          <p:nvPr/>
        </p:nvSpPr>
        <p:spPr>
          <a:xfrm>
            <a:off x="7997021" y="2681418"/>
            <a:ext cx="733021" cy="33233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52169F2-BC55-DF63-CC88-30CB2038F468}"/>
              </a:ext>
            </a:extLst>
          </p:cNvPr>
          <p:cNvSpPr txBox="1"/>
          <p:nvPr/>
        </p:nvSpPr>
        <p:spPr>
          <a:xfrm>
            <a:off x="2770773" y="2673831"/>
            <a:ext cx="1131544" cy="332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RT+BT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C2983F1-3AEF-1502-969B-F13C42EEB210}"/>
              </a:ext>
            </a:extLst>
          </p:cNvPr>
          <p:cNvSpPr txBox="1"/>
          <p:nvPr/>
        </p:nvSpPr>
        <p:spPr>
          <a:xfrm>
            <a:off x="2614518" y="2338179"/>
            <a:ext cx="1336998" cy="276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DP 40 mg/m</a:t>
            </a:r>
            <a:r>
              <a:rPr kumimoji="1" lang="en-US" altLang="ja-JP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4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EA294F3-B840-0714-1BF8-5AACB009F7E9}"/>
              </a:ext>
            </a:extLst>
          </p:cNvPr>
          <p:cNvSpPr txBox="1"/>
          <p:nvPr/>
        </p:nvSpPr>
        <p:spPr>
          <a:xfrm>
            <a:off x="837767" y="2522943"/>
            <a:ext cx="1812522" cy="332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BT or IC/ISBT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E19A067-A9A7-6A93-B082-131F7ABD8EC5}"/>
              </a:ext>
            </a:extLst>
          </p:cNvPr>
          <p:cNvSpPr txBox="1"/>
          <p:nvPr/>
        </p:nvSpPr>
        <p:spPr>
          <a:xfrm>
            <a:off x="9211576" y="2689108"/>
            <a:ext cx="733021" cy="332330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矢印: 右 50">
            <a:extLst>
              <a:ext uri="{FF2B5EF4-FFF2-40B4-BE49-F238E27FC236}">
                <a16:creationId xmlns:a16="http://schemas.microsoft.com/office/drawing/2014/main" id="{291A88A6-413B-32EC-0C55-C31E0FBA98B9}"/>
              </a:ext>
            </a:extLst>
          </p:cNvPr>
          <p:cNvSpPr/>
          <p:nvPr/>
        </p:nvSpPr>
        <p:spPr>
          <a:xfrm>
            <a:off x="4052934" y="655780"/>
            <a:ext cx="6916421" cy="249306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2643528-B26F-4922-C980-F08CD7A9D2F0}"/>
              </a:ext>
            </a:extLst>
          </p:cNvPr>
          <p:cNvSpPr txBox="1"/>
          <p:nvPr/>
        </p:nvSpPr>
        <p:spPr>
          <a:xfrm>
            <a:off x="4021645" y="970866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604FE8B-7D46-EE89-0256-6F6D5A1D0A1B}"/>
              </a:ext>
            </a:extLst>
          </p:cNvPr>
          <p:cNvSpPr txBox="1"/>
          <p:nvPr/>
        </p:nvSpPr>
        <p:spPr>
          <a:xfrm>
            <a:off x="4832454" y="983753"/>
            <a:ext cx="759883" cy="2492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7B452EE-C305-2A30-A0AB-AC690B969D57}"/>
              </a:ext>
            </a:extLst>
          </p:cNvPr>
          <p:cNvSpPr txBox="1"/>
          <p:nvPr/>
        </p:nvSpPr>
        <p:spPr>
          <a:xfrm>
            <a:off x="5649601" y="1002243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rd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B458B988-298C-BE4D-CAFE-CCC018D64AB7}"/>
              </a:ext>
            </a:extLst>
          </p:cNvPr>
          <p:cNvSpPr txBox="1"/>
          <p:nvPr/>
        </p:nvSpPr>
        <p:spPr>
          <a:xfrm>
            <a:off x="6398625" y="993995"/>
            <a:ext cx="729267" cy="2492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th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2FCD020-9950-A717-521B-BAEFB1AA97D7}"/>
              </a:ext>
            </a:extLst>
          </p:cNvPr>
          <p:cNvSpPr txBox="1"/>
          <p:nvPr/>
        </p:nvSpPr>
        <p:spPr>
          <a:xfrm>
            <a:off x="7139073" y="991636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th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766003F-2EBF-AE0C-8C75-ECBC6512C39A}"/>
              </a:ext>
            </a:extLst>
          </p:cNvPr>
          <p:cNvSpPr txBox="1"/>
          <p:nvPr/>
        </p:nvSpPr>
        <p:spPr>
          <a:xfrm>
            <a:off x="7808464" y="986733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th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7E65EE3-1126-242B-DC3C-9CE4AD0582E6}"/>
              </a:ext>
            </a:extLst>
          </p:cNvPr>
          <p:cNvSpPr txBox="1"/>
          <p:nvPr/>
        </p:nvSpPr>
        <p:spPr>
          <a:xfrm>
            <a:off x="8467328" y="988737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th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54961354-27EB-E66D-38F4-615FADA38A9C}"/>
              </a:ext>
            </a:extLst>
          </p:cNvPr>
          <p:cNvGrpSpPr/>
          <p:nvPr/>
        </p:nvGrpSpPr>
        <p:grpSpPr>
          <a:xfrm>
            <a:off x="3560549" y="3966846"/>
            <a:ext cx="984771" cy="950307"/>
            <a:chOff x="2981767" y="2534787"/>
            <a:chExt cx="1082748" cy="1056114"/>
          </a:xfrm>
        </p:grpSpPr>
        <p:sp>
          <p:nvSpPr>
            <p:cNvPr id="2" name="楕円 1">
              <a:extLst>
                <a:ext uri="{FF2B5EF4-FFF2-40B4-BE49-F238E27FC236}">
                  <a16:creationId xmlns:a16="http://schemas.microsoft.com/office/drawing/2014/main" id="{CE1A71BF-E115-9DB0-3F15-E67503DAF524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7B9A0185-CF98-1420-78E5-6A138F672F4C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128F7F75-B31E-FFF3-A7BD-06C44BAB6778}"/>
              </a:ext>
            </a:extLst>
          </p:cNvPr>
          <p:cNvGrpSpPr/>
          <p:nvPr/>
        </p:nvGrpSpPr>
        <p:grpSpPr>
          <a:xfrm>
            <a:off x="5935866" y="3958638"/>
            <a:ext cx="984771" cy="950307"/>
            <a:chOff x="2981767" y="2534787"/>
            <a:chExt cx="1082748" cy="1056114"/>
          </a:xfrm>
        </p:grpSpPr>
        <p:sp>
          <p:nvSpPr>
            <p:cNvPr id="9" name="楕円 8">
              <a:extLst>
                <a:ext uri="{FF2B5EF4-FFF2-40B4-BE49-F238E27FC236}">
                  <a16:creationId xmlns:a16="http://schemas.microsoft.com/office/drawing/2014/main" id="{001C8955-0729-02AF-BBBF-DEFA2D3387BB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1330CE21-1405-459D-6DBC-E983DAC7E9FD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10B9255-7353-E863-DA14-621B279B5D76}"/>
              </a:ext>
            </a:extLst>
          </p:cNvPr>
          <p:cNvSpPr/>
          <p:nvPr/>
        </p:nvSpPr>
        <p:spPr>
          <a:xfrm>
            <a:off x="7553376" y="2669039"/>
            <a:ext cx="440271" cy="1016124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/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</a:p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9167C6C-DF8D-4D5A-CDFF-4D56BA886526}"/>
              </a:ext>
            </a:extLst>
          </p:cNvPr>
          <p:cNvSpPr/>
          <p:nvPr/>
        </p:nvSpPr>
        <p:spPr>
          <a:xfrm>
            <a:off x="8732954" y="2689108"/>
            <a:ext cx="480883" cy="1016124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/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</a:p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DAA2FCC-B5CD-436E-954B-83CDF05AF1AC}"/>
              </a:ext>
            </a:extLst>
          </p:cNvPr>
          <p:cNvSpPr/>
          <p:nvPr/>
        </p:nvSpPr>
        <p:spPr>
          <a:xfrm>
            <a:off x="10202078" y="2682409"/>
            <a:ext cx="440272" cy="1016124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/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</a:p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AC0A308-9434-7C20-DF71-685870F6198A}"/>
              </a:ext>
            </a:extLst>
          </p:cNvPr>
          <p:cNvSpPr txBox="1"/>
          <p:nvPr/>
        </p:nvSpPr>
        <p:spPr>
          <a:xfrm>
            <a:off x="9216696" y="992998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th Week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CF358886-D520-F95B-11B1-0DA7F5D1CCC9}"/>
              </a:ext>
            </a:extLst>
          </p:cNvPr>
          <p:cNvGrpSpPr/>
          <p:nvPr/>
        </p:nvGrpSpPr>
        <p:grpSpPr>
          <a:xfrm>
            <a:off x="5917110" y="1655076"/>
            <a:ext cx="984771" cy="950307"/>
            <a:chOff x="2981767" y="2534787"/>
            <a:chExt cx="1082748" cy="1056114"/>
          </a:xfrm>
        </p:grpSpPr>
        <p:sp>
          <p:nvSpPr>
            <p:cNvPr id="14" name="楕円 13">
              <a:extLst>
                <a:ext uri="{FF2B5EF4-FFF2-40B4-BE49-F238E27FC236}">
                  <a16:creationId xmlns:a16="http://schemas.microsoft.com/office/drawing/2014/main" id="{4D970923-9127-F8B8-184A-0E5D57C448D2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D60B05FD-DB9E-10B1-5423-A8C940AB01C1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8A836062-C02E-8FA5-2261-9C43064507CF}"/>
              </a:ext>
            </a:extLst>
          </p:cNvPr>
          <p:cNvGrpSpPr/>
          <p:nvPr/>
        </p:nvGrpSpPr>
        <p:grpSpPr>
          <a:xfrm>
            <a:off x="7285252" y="1639123"/>
            <a:ext cx="984771" cy="950307"/>
            <a:chOff x="2981767" y="2534787"/>
            <a:chExt cx="1082748" cy="1056114"/>
          </a:xfrm>
        </p:grpSpPr>
        <p:sp>
          <p:nvSpPr>
            <p:cNvPr id="33" name="楕円 32">
              <a:extLst>
                <a:ext uri="{FF2B5EF4-FFF2-40B4-BE49-F238E27FC236}">
                  <a16:creationId xmlns:a16="http://schemas.microsoft.com/office/drawing/2014/main" id="{BC556DC3-DEEC-6F82-CEFD-DA60581B95CD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直線矢印コネクタ 58">
              <a:extLst>
                <a:ext uri="{FF2B5EF4-FFF2-40B4-BE49-F238E27FC236}">
                  <a16:creationId xmlns:a16="http://schemas.microsoft.com/office/drawing/2014/main" id="{828A5BC6-0F21-891C-68C5-DF935F995D73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96BEB71C-9666-21F0-E283-B64A2F71B315}"/>
              </a:ext>
            </a:extLst>
          </p:cNvPr>
          <p:cNvGrpSpPr/>
          <p:nvPr/>
        </p:nvGrpSpPr>
        <p:grpSpPr>
          <a:xfrm>
            <a:off x="8468457" y="1642968"/>
            <a:ext cx="984771" cy="950307"/>
            <a:chOff x="2981767" y="2534787"/>
            <a:chExt cx="1082748" cy="1056114"/>
          </a:xfrm>
        </p:grpSpPr>
        <p:sp>
          <p:nvSpPr>
            <p:cNvPr id="61" name="楕円 60">
              <a:extLst>
                <a:ext uri="{FF2B5EF4-FFF2-40B4-BE49-F238E27FC236}">
                  <a16:creationId xmlns:a16="http://schemas.microsoft.com/office/drawing/2014/main" id="{CFCD78FD-453C-F9E1-30FB-177B9D4BEDD3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2" name="直線矢印コネクタ 61">
              <a:extLst>
                <a:ext uri="{FF2B5EF4-FFF2-40B4-BE49-F238E27FC236}">
                  <a16:creationId xmlns:a16="http://schemas.microsoft.com/office/drawing/2014/main" id="{DEA0F164-A8A0-89B8-880D-DBC41EB4F254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F2A40457-D90E-E299-C9DD-35B9931CD093}"/>
              </a:ext>
            </a:extLst>
          </p:cNvPr>
          <p:cNvGrpSpPr/>
          <p:nvPr/>
        </p:nvGrpSpPr>
        <p:grpSpPr>
          <a:xfrm>
            <a:off x="9711846" y="1642968"/>
            <a:ext cx="984771" cy="950307"/>
            <a:chOff x="2981767" y="2534787"/>
            <a:chExt cx="1082748" cy="1056114"/>
          </a:xfrm>
        </p:grpSpPr>
        <p:sp>
          <p:nvSpPr>
            <p:cNvPr id="64" name="楕円 63">
              <a:extLst>
                <a:ext uri="{FF2B5EF4-FFF2-40B4-BE49-F238E27FC236}">
                  <a16:creationId xmlns:a16="http://schemas.microsoft.com/office/drawing/2014/main" id="{918A9B7D-7EAB-7EB8-AB6D-98ABA026265B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" name="直線矢印コネクタ 64">
              <a:extLst>
                <a:ext uri="{FF2B5EF4-FFF2-40B4-BE49-F238E27FC236}">
                  <a16:creationId xmlns:a16="http://schemas.microsoft.com/office/drawing/2014/main" id="{98403BF9-D193-386D-74F7-6FAE25622B1F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B5A82A0D-79CD-5392-A566-613092B6514B}"/>
              </a:ext>
            </a:extLst>
          </p:cNvPr>
          <p:cNvGrpSpPr/>
          <p:nvPr/>
        </p:nvGrpSpPr>
        <p:grpSpPr>
          <a:xfrm>
            <a:off x="3571471" y="1615698"/>
            <a:ext cx="984771" cy="950307"/>
            <a:chOff x="2981767" y="2534787"/>
            <a:chExt cx="1082748" cy="1056114"/>
          </a:xfrm>
        </p:grpSpPr>
        <p:sp>
          <p:nvSpPr>
            <p:cNvPr id="67" name="楕円 66">
              <a:extLst>
                <a:ext uri="{FF2B5EF4-FFF2-40B4-BE49-F238E27FC236}">
                  <a16:creationId xmlns:a16="http://schemas.microsoft.com/office/drawing/2014/main" id="{777010BE-CDE9-3DDA-16AE-B11E0C000272}"/>
                </a:ext>
              </a:extLst>
            </p:cNvPr>
            <p:cNvSpPr/>
            <p:nvPr/>
          </p:nvSpPr>
          <p:spPr>
            <a:xfrm>
              <a:off x="2981767" y="2534787"/>
              <a:ext cx="1082748" cy="446451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8" name="直線矢印コネクタ 67">
              <a:extLst>
                <a:ext uri="{FF2B5EF4-FFF2-40B4-BE49-F238E27FC236}">
                  <a16:creationId xmlns:a16="http://schemas.microsoft.com/office/drawing/2014/main" id="{C866ABCB-4003-8526-608A-64BD3A88FE35}"/>
                </a:ext>
              </a:extLst>
            </p:cNvPr>
            <p:cNvCxnSpPr/>
            <p:nvPr/>
          </p:nvCxnSpPr>
          <p:spPr>
            <a:xfrm>
              <a:off x="3523141" y="2962125"/>
              <a:ext cx="0" cy="628776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矢印: 下 47">
            <a:extLst>
              <a:ext uri="{FF2B5EF4-FFF2-40B4-BE49-F238E27FC236}">
                <a16:creationId xmlns:a16="http://schemas.microsoft.com/office/drawing/2014/main" id="{AC7A4EB6-5EEF-B2F2-BDD3-A3C91D983D28}"/>
              </a:ext>
            </a:extLst>
          </p:cNvPr>
          <p:cNvSpPr/>
          <p:nvPr/>
        </p:nvSpPr>
        <p:spPr>
          <a:xfrm>
            <a:off x="8559186" y="4645395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矢印: 下 69">
            <a:extLst>
              <a:ext uri="{FF2B5EF4-FFF2-40B4-BE49-F238E27FC236}">
                <a16:creationId xmlns:a16="http://schemas.microsoft.com/office/drawing/2014/main" id="{6E944423-F8DD-7C63-BEE3-8A09A7ECD224}"/>
              </a:ext>
            </a:extLst>
          </p:cNvPr>
          <p:cNvSpPr/>
          <p:nvPr/>
        </p:nvSpPr>
        <p:spPr>
          <a:xfrm>
            <a:off x="9227037" y="2337621"/>
            <a:ext cx="147273" cy="2999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85AFB9C-6434-A7CB-083E-11FDFD0560AA}"/>
              </a:ext>
            </a:extLst>
          </p:cNvPr>
          <p:cNvSpPr txBox="1"/>
          <p:nvPr/>
        </p:nvSpPr>
        <p:spPr>
          <a:xfrm>
            <a:off x="2549770" y="4626183"/>
            <a:ext cx="1336998" cy="276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DP 40 mg/m</a:t>
            </a:r>
            <a:r>
              <a:rPr kumimoji="1" lang="en-US" altLang="ja-JP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4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8CF7BE5-7C79-0CBA-1A16-F12890D51309}"/>
              </a:ext>
            </a:extLst>
          </p:cNvPr>
          <p:cNvSpPr txBox="1"/>
          <p:nvPr/>
        </p:nvSpPr>
        <p:spPr>
          <a:xfrm>
            <a:off x="1611" y="5781640"/>
            <a:ext cx="12224600" cy="1030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altLang="ja-JP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ypical treatment scheme for patients with cT3BN1M0, </a:t>
            </a:r>
          </a:p>
          <a:p>
            <a:pPr algn="ctr">
              <a:lnSpc>
                <a:spcPct val="115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BRT 30Gy/15fr+CS20Gy/2wks+LN boost 6Gy/3fr +</a:t>
            </a:r>
            <a:r>
              <a:rPr lang="en-US" altLang="ja-JP" b="1" kern="100" dirty="0"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current chemotherapy;</a:t>
            </a:r>
            <a:r>
              <a:rPr lang="en-US" altLang="ja-JP" sz="1800" b="1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 CDDP 6 times (once a week) </a:t>
            </a:r>
            <a:endParaRPr lang="ja-JP" altLang="ja-JP" sz="1800" b="1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</a:pPr>
            <a:r>
              <a:rPr lang="en-US" altLang="ja-JP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per panel; ICBT or IC/ISBT 26Gy/4fr, Lower panel; ISBT 30Gy/5fr 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61784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</TotalTime>
  <Words>134</Words>
  <Application>Microsoft Office PowerPoint</Application>
  <PresentationFormat>Widescreen</PresentationFormat>
  <Paragraphs>5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deya yamazaki</dc:creator>
  <cp:lastModifiedBy>MDPI</cp:lastModifiedBy>
  <cp:revision>33</cp:revision>
  <cp:lastPrinted>2024-12-16T06:35:06Z</cp:lastPrinted>
  <dcterms:created xsi:type="dcterms:W3CDTF">2024-12-05T07:04:59Z</dcterms:created>
  <dcterms:modified xsi:type="dcterms:W3CDTF">2025-02-24T03:27:23Z</dcterms:modified>
</cp:coreProperties>
</file>